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79CB24-38C3-79AE-2143-B5A4997B13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B99DB5B-DF42-1541-44CF-3F61E39A5E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F856A1-1796-545A-7D31-88EC9FDD63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855CEF-B2A3-5F27-B027-00200D0AD9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460859-C5BE-06D1-8758-1F187520ED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4977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AECF11-A83B-D09D-C275-915B44E719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C86E07-10B5-7AA2-3B2B-FE4F57D89E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E911B5-00C0-1446-85C3-0EC0ADDD94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2C1CFA-FE5E-33F7-232F-185617563F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1467E6-5E77-3BEF-7C8F-5761EA782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8999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A8ADA38-CA22-F565-59CB-E903BC44DE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D79850-A514-A337-16F1-DC9F6A8DB3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D3337C-DCF0-E098-31AF-8D6604B12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76D9F1-299F-EFDB-ACBF-F15A6B9F9A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3955DA-12FD-3D3F-F878-34D2B30402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7109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0065DE-7CB2-0F44-DE31-AFB83B512C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A2F680-8700-2237-B3EB-7DE5D3341CD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A94465-5D26-4516-F59F-84B0C05446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BFD60C-4059-427F-8FDA-CCF3670309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CCE32A-744A-A6C1-330F-02120334B0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15979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91285E-B7E4-CAE3-DEBA-06C31FF1EB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4A9AFA-BAA5-AE9F-ED25-45CAF2E076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30221E-6FB9-05E4-424D-129DD29277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5EE191-65D9-C83C-AD19-02759C4E4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BD03BF-04F6-07D1-26C6-685F81E080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6634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15C5B8-748D-0E5C-D206-BE20CE2E22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6A3992-F537-D149-9443-21E6E1A9ED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5CB345D-F217-0F19-A5B1-63519F9737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852FF1-476C-69D6-9E22-8DB38FD0DD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C6B846-A922-D283-4E36-1AFBB28C31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900C72-5B36-1104-D905-43487AD7A5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9231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ED4E0A-9352-A89F-EB56-D5F03C30DB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2BEBE4-0CDB-EC76-8B01-2C745E367F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33C7DDD-0E06-6F00-6DF4-4308479A26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8C4E999-A01E-CCB9-F332-4271BB98508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EB7CE03-4E44-050C-8AE6-9D545B4FDD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5776E9F-4A03-FD05-18DE-5F5E08DC23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8F7AD89-9A47-DC38-88E3-6C1FA8FA13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4031AC4-0A9B-EADD-688F-5887D56AB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665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9FE0B1-B762-2DDD-ADF3-EB45536A40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48DCD74-5AB9-2F73-3BC5-C9FED58DE1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6C970FC-920F-8195-A2D7-AAEFA5D5AC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AE5CCDC-E77E-AE92-C425-D85A09A535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41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5BBA306-BF16-0F48-630C-5C3D8389C3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B8326BF-C759-403C-8E09-3FC656E72A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98EEC72-1126-30F8-6FDF-FC25FD9DC3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0440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EEF9AA-0C99-3BF3-2885-CF9A2C5DF9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18E782-BB65-C57D-5DAB-93DE74CD9EC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348E3B3-E707-02F8-847C-B2252F0202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20C773-332F-2D40-9FEE-8C830D50C4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DCD5C9-4D3A-B576-46C8-22B56A0A84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7D200D-D482-E961-272D-E9E4EA952A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59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9F4072-2451-CF96-96D4-7D391EA5E3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F549CD9-4D06-2E2B-8655-3E5F011FCC8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6A5EC0B-FB46-6313-A40A-D699EF6BCE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9ED5D0-39B1-547C-055D-C5DB413A70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EA4C80-C9E1-1F9D-34DD-C3E592EE49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49F1D8-CCBF-F0A0-464B-CF8CE7A011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923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1E1F0BC-1C6E-E892-7635-F793AE5E80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DA04E3-3D7A-A023-5277-A781CF819D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73CDA6-D7E6-B2F4-1F66-B839DA480D0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6701F3-7979-8DAC-C6C7-626D985765A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5A4BAF-559A-6EF5-0C0F-D273B763E71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44911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14F9511-0E2E-3385-367C-BE220880C704}"/>
              </a:ext>
            </a:extLst>
          </p:cNvPr>
          <p:cNvCxnSpPr>
            <a:cxnSpLocks/>
          </p:cNvCxnSpPr>
          <p:nvPr/>
        </p:nvCxnSpPr>
        <p:spPr>
          <a:xfrm>
            <a:off x="278904" y="2530674"/>
            <a:ext cx="69628" cy="3926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00F14FC2-44BD-C811-5522-C61CED656DE2}"/>
              </a:ext>
            </a:extLst>
          </p:cNvPr>
          <p:cNvCxnSpPr>
            <a:cxnSpLocks/>
          </p:cNvCxnSpPr>
          <p:nvPr/>
        </p:nvCxnSpPr>
        <p:spPr>
          <a:xfrm>
            <a:off x="215197" y="2957644"/>
            <a:ext cx="3177" cy="4542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3E5E0B17-25EA-1333-7847-A3C2B6982D57}"/>
              </a:ext>
            </a:extLst>
          </p:cNvPr>
          <p:cNvSpPr txBox="1"/>
          <p:nvPr/>
        </p:nvSpPr>
        <p:spPr>
          <a:xfrm>
            <a:off x="196409" y="2082785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2130_Brain 1</a:t>
            </a:r>
          </a:p>
        </p:txBody>
      </p:sp>
      <p:pic>
        <p:nvPicPr>
          <p:cNvPr id="7" name="Picture 6" descr="A picture containing blue&#10;&#10;Description automatically generated">
            <a:extLst>
              <a:ext uri="{FF2B5EF4-FFF2-40B4-BE49-F238E27FC236}">
                <a16:creationId xmlns:a16="http://schemas.microsoft.com/office/drawing/2014/main" id="{F88AC43F-1EC5-1031-E9A0-8A60DD23FC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18078" y="350327"/>
            <a:ext cx="3951377" cy="2281697"/>
          </a:xfrm>
          <a:prstGeom prst="rect">
            <a:avLst/>
          </a:prstGeom>
        </p:spPr>
      </p:pic>
      <p:pic>
        <p:nvPicPr>
          <p:cNvPr id="10" name="Picture 9" descr="A picture containing dark&#10;&#10;Description automatically generated">
            <a:extLst>
              <a:ext uri="{FF2B5EF4-FFF2-40B4-BE49-F238E27FC236}">
                <a16:creationId xmlns:a16="http://schemas.microsoft.com/office/drawing/2014/main" id="{B58CF239-C4B8-3DD4-2BD6-AB4403042BC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89807" y="373467"/>
            <a:ext cx="3921668" cy="2150976"/>
          </a:xfrm>
          <a:prstGeom prst="rect">
            <a:avLst/>
          </a:prstGeom>
        </p:spPr>
      </p:pic>
      <p:pic>
        <p:nvPicPr>
          <p:cNvPr id="14" name="Picture 13" descr="A picture containing invertebrate, jellyfish&#10;&#10;Description automatically generated">
            <a:extLst>
              <a:ext uri="{FF2B5EF4-FFF2-40B4-BE49-F238E27FC236}">
                <a16:creationId xmlns:a16="http://schemas.microsoft.com/office/drawing/2014/main" id="{4FA2D4A6-9BAF-B8EC-48B7-D25E04A4AE2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876" y="2722204"/>
            <a:ext cx="3927609" cy="2263872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FDDD87AE-3E43-8E06-0243-28CAEE29D194}"/>
              </a:ext>
            </a:extLst>
          </p:cNvPr>
          <p:cNvSpPr txBox="1"/>
          <p:nvPr/>
        </p:nvSpPr>
        <p:spPr>
          <a:xfrm>
            <a:off x="4141843" y="2164854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2130_Brain 2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5764C8E2-ABF5-B5F6-1F20-964D992D132B}"/>
              </a:ext>
            </a:extLst>
          </p:cNvPr>
          <p:cNvSpPr txBox="1"/>
          <p:nvPr/>
        </p:nvSpPr>
        <p:spPr>
          <a:xfrm>
            <a:off x="8060566" y="2164854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2130_Brain 3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DAB865A-3E0B-E88C-A7FF-7939E841A3E1}"/>
              </a:ext>
            </a:extLst>
          </p:cNvPr>
          <p:cNvSpPr txBox="1"/>
          <p:nvPr/>
        </p:nvSpPr>
        <p:spPr>
          <a:xfrm>
            <a:off x="199720" y="4639788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2130_Brain 4</a:t>
            </a:r>
          </a:p>
        </p:txBody>
      </p:sp>
      <p:pic>
        <p:nvPicPr>
          <p:cNvPr id="22" name="Picture 21" descr="A picture containing coelenterate, jellyfish&#10;&#10;Description automatically generated">
            <a:extLst>
              <a:ext uri="{FF2B5EF4-FFF2-40B4-BE49-F238E27FC236}">
                <a16:creationId xmlns:a16="http://schemas.microsoft.com/office/drawing/2014/main" id="{0805FB73-9F7D-2CA2-2948-79B5218E5E2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46950" y="2753395"/>
            <a:ext cx="3910032" cy="2073144"/>
          </a:xfrm>
          <a:prstGeom prst="rect">
            <a:avLst/>
          </a:prstGeom>
        </p:spPr>
      </p:pic>
      <p:pic>
        <p:nvPicPr>
          <p:cNvPr id="25" name="Picture 24" descr="A picture containing invertebrate, coelenterate, jellyfish, ocean floor&#10;&#10;Description automatically generated">
            <a:extLst>
              <a:ext uri="{FF2B5EF4-FFF2-40B4-BE49-F238E27FC236}">
                <a16:creationId xmlns:a16="http://schemas.microsoft.com/office/drawing/2014/main" id="{A93AC430-E0EB-0E9D-DFA9-8958B9284E4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117296" y="2715004"/>
            <a:ext cx="3915938" cy="2149927"/>
          </a:xfrm>
          <a:prstGeom prst="rect">
            <a:avLst/>
          </a:prstGeom>
        </p:spPr>
      </p:pic>
      <p:pic>
        <p:nvPicPr>
          <p:cNvPr id="27" name="Picture 26" descr="A picture containing invertebrate&#10;&#10;Description automatically generated">
            <a:extLst>
              <a:ext uri="{FF2B5EF4-FFF2-40B4-BE49-F238E27FC236}">
                <a16:creationId xmlns:a16="http://schemas.microsoft.com/office/drawing/2014/main" id="{BFEFFB30-C807-7F01-98E8-57F589D8E86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15782" y="4864931"/>
            <a:ext cx="3951377" cy="2102676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2150518B-FF62-706E-8A55-1365D3ECECDF}"/>
              </a:ext>
            </a:extLst>
          </p:cNvPr>
          <p:cNvSpPr txBox="1"/>
          <p:nvPr/>
        </p:nvSpPr>
        <p:spPr>
          <a:xfrm>
            <a:off x="4256744" y="4418816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2121_Brain 1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B5E6B6B-978E-8FB1-502F-CD77BD67204D}"/>
              </a:ext>
            </a:extLst>
          </p:cNvPr>
          <p:cNvSpPr txBox="1"/>
          <p:nvPr/>
        </p:nvSpPr>
        <p:spPr>
          <a:xfrm>
            <a:off x="8166776" y="4418816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2121_Brain 2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34FCE7D8-7CF2-A75D-F79F-6F972BE9E244}"/>
              </a:ext>
            </a:extLst>
          </p:cNvPr>
          <p:cNvSpPr txBox="1"/>
          <p:nvPr/>
        </p:nvSpPr>
        <p:spPr>
          <a:xfrm>
            <a:off x="4251207" y="6366000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2121_Brain 3</a:t>
            </a: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19496C71-E700-C1CC-E7D9-F5AC324E8B0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3876" y="382755"/>
            <a:ext cx="3919492" cy="2260791"/>
          </a:xfrm>
          <a:prstGeom prst="rect">
            <a:avLst/>
          </a:prstGeom>
        </p:spPr>
      </p:pic>
      <p:sp>
        <p:nvSpPr>
          <p:cNvPr id="50" name="TextBox 49">
            <a:extLst>
              <a:ext uri="{FF2B5EF4-FFF2-40B4-BE49-F238E27FC236}">
                <a16:creationId xmlns:a16="http://schemas.microsoft.com/office/drawing/2014/main" id="{F677E558-E156-E268-51C6-058934A83721}"/>
              </a:ext>
            </a:extLst>
          </p:cNvPr>
          <p:cNvSpPr txBox="1"/>
          <p:nvPr/>
        </p:nvSpPr>
        <p:spPr>
          <a:xfrm>
            <a:off x="120874" y="2164854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2130_Brain 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BD87DE3-10EB-1734-9F9C-1121D731845A}"/>
              </a:ext>
            </a:extLst>
          </p:cNvPr>
          <p:cNvSpPr txBox="1"/>
          <p:nvPr/>
        </p:nvSpPr>
        <p:spPr>
          <a:xfrm>
            <a:off x="1741818" y="1796778"/>
            <a:ext cx="19672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MBON-g   dendritic tufts</a:t>
            </a:r>
          </a:p>
        </p:txBody>
      </p: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40DD2687-A240-9D5F-C6F3-B48C2E5F67F4}"/>
              </a:ext>
            </a:extLst>
          </p:cNvPr>
          <p:cNvCxnSpPr>
            <a:cxnSpLocks/>
          </p:cNvCxnSpPr>
          <p:nvPr/>
        </p:nvCxnSpPr>
        <p:spPr>
          <a:xfrm flipH="1" flipV="1">
            <a:off x="1888211" y="1463397"/>
            <a:ext cx="121329" cy="363885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6A63112B-13FC-6107-EFDD-FD163A56D583}"/>
              </a:ext>
            </a:extLst>
          </p:cNvPr>
          <p:cNvCxnSpPr>
            <a:cxnSpLocks/>
          </p:cNvCxnSpPr>
          <p:nvPr/>
        </p:nvCxnSpPr>
        <p:spPr>
          <a:xfrm flipH="1" flipV="1">
            <a:off x="2092863" y="1485167"/>
            <a:ext cx="121329" cy="363885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BCC349B0-5588-17B3-5A9D-5420BEBF27AD}"/>
              </a:ext>
            </a:extLst>
          </p:cNvPr>
          <p:cNvCxnSpPr>
            <a:cxnSpLocks/>
          </p:cNvCxnSpPr>
          <p:nvPr/>
        </p:nvCxnSpPr>
        <p:spPr>
          <a:xfrm flipV="1">
            <a:off x="5694763" y="1520110"/>
            <a:ext cx="308911" cy="250457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27366606-539E-4E57-568E-77D2BD70553E}"/>
              </a:ext>
            </a:extLst>
          </p:cNvPr>
          <p:cNvCxnSpPr>
            <a:cxnSpLocks/>
          </p:cNvCxnSpPr>
          <p:nvPr/>
        </p:nvCxnSpPr>
        <p:spPr>
          <a:xfrm flipV="1">
            <a:off x="5806485" y="3849947"/>
            <a:ext cx="308911" cy="250457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B4415CF3-6293-8315-FF6D-0BDA1DE2E8C1}"/>
              </a:ext>
            </a:extLst>
          </p:cNvPr>
          <p:cNvCxnSpPr>
            <a:cxnSpLocks/>
          </p:cNvCxnSpPr>
          <p:nvPr/>
        </p:nvCxnSpPr>
        <p:spPr>
          <a:xfrm flipV="1">
            <a:off x="9680208" y="3847351"/>
            <a:ext cx="308911" cy="250457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D124C1B8-5E0D-99CD-5A93-A633694B8449}"/>
              </a:ext>
            </a:extLst>
          </p:cNvPr>
          <p:cNvCxnSpPr>
            <a:cxnSpLocks/>
          </p:cNvCxnSpPr>
          <p:nvPr/>
        </p:nvCxnSpPr>
        <p:spPr>
          <a:xfrm flipV="1">
            <a:off x="5699056" y="5883268"/>
            <a:ext cx="308911" cy="250457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73227186-183D-BD98-5541-CA53CC3C3B34}"/>
              </a:ext>
            </a:extLst>
          </p:cNvPr>
          <p:cNvCxnSpPr>
            <a:cxnSpLocks/>
          </p:cNvCxnSpPr>
          <p:nvPr/>
        </p:nvCxnSpPr>
        <p:spPr>
          <a:xfrm flipV="1">
            <a:off x="1614304" y="3818480"/>
            <a:ext cx="201746" cy="389769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478A733C-895F-8E3F-7E52-E4880DC28788}"/>
              </a:ext>
            </a:extLst>
          </p:cNvPr>
          <p:cNvCxnSpPr>
            <a:cxnSpLocks/>
          </p:cNvCxnSpPr>
          <p:nvPr/>
        </p:nvCxnSpPr>
        <p:spPr>
          <a:xfrm flipV="1">
            <a:off x="9813033" y="1466374"/>
            <a:ext cx="201746" cy="389769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E7450C55-EF2C-0598-8DF4-D03EA89B8308}"/>
              </a:ext>
            </a:extLst>
          </p:cNvPr>
          <p:cNvCxnSpPr>
            <a:cxnSpLocks/>
          </p:cNvCxnSpPr>
          <p:nvPr/>
        </p:nvCxnSpPr>
        <p:spPr>
          <a:xfrm flipH="1" flipV="1">
            <a:off x="10265881" y="1448955"/>
            <a:ext cx="201746" cy="389769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078FA33C-3097-5E96-8E49-0B5FDA446E19}"/>
              </a:ext>
            </a:extLst>
          </p:cNvPr>
          <p:cNvCxnSpPr>
            <a:cxnSpLocks/>
          </p:cNvCxnSpPr>
          <p:nvPr/>
        </p:nvCxnSpPr>
        <p:spPr>
          <a:xfrm flipH="1" flipV="1">
            <a:off x="2104491" y="3818480"/>
            <a:ext cx="201746" cy="389769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id="{6C8D8368-49E1-9D49-DD49-BEAA0F42507D}"/>
              </a:ext>
            </a:extLst>
          </p:cNvPr>
          <p:cNvSpPr txBox="1"/>
          <p:nvPr/>
        </p:nvSpPr>
        <p:spPr>
          <a:xfrm>
            <a:off x="-38790" y="29163"/>
            <a:ext cx="61013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dult immortalized anatomy of larval neurons MBON-g1, -g2</a:t>
            </a:r>
          </a:p>
        </p:txBody>
      </p:sp>
    </p:spTree>
    <p:extLst>
      <p:ext uri="{BB962C8B-B14F-4D97-AF65-F5344CB8AC3E}">
        <p14:creationId xmlns:p14="http://schemas.microsoft.com/office/powerpoint/2010/main" val="13343817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45</Words>
  <Application>Microsoft Macintosh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uman, Jim</dc:creator>
  <cp:lastModifiedBy>Truman, Jim</cp:lastModifiedBy>
  <cp:revision>13</cp:revision>
  <dcterms:created xsi:type="dcterms:W3CDTF">2022-06-08T22:16:26Z</dcterms:created>
  <dcterms:modified xsi:type="dcterms:W3CDTF">2022-06-08T22:54:21Z</dcterms:modified>
</cp:coreProperties>
</file>